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C10A8-41BD-4323-97C5-9BDB717B6C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8C2CD-A56D-491E-8A0B-AEC727BF86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B5929-C143-4B7F-A6D5-9320FBAA80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040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4672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040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4672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7C7C57-1920-4BC2-B945-68546BE28E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FD8FD-B1B6-4C20-AF2E-5BF9A1A2F3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64BA6-1CEB-46F0-B0E2-3161D11F1F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B998C6-05AB-48F0-8C52-1B4A68525C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0EAAB-B2F9-4910-A399-905095C801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812520"/>
            <a:ext cx="5815080" cy="699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C6C0B1-0764-4381-B20A-8DA692A7B2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0F56D-7ADB-418E-B0AD-FCC3CD40A3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19C69-5938-4452-890F-852045CC1D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7DEAC-94E1-4765-B4FC-4ECAB13D07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31120"/>
            <a:ext cx="215748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43D8079E-8878-45A7-AE3D-3A667103FAA2}" type="slidenum">
              <a: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"/>
          <p:cNvSpPr/>
          <p:nvPr/>
        </p:nvSpPr>
        <p:spPr>
          <a:xfrm>
            <a:off x="0" y="8532720"/>
            <a:ext cx="6858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S6 Fig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xpression levels of TH transporters and TRs in 15-day-old WT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Csb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m/m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/Xpa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 (A), 16-week-old WT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rcc1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Δ-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 (B) and 13-week-old and 130-week-old WT mice (C). Values represent mean ± SE. * P &lt; 0.05; ** P &lt; 0.001.</a:t>
            </a:r>
            <a:endParaRPr b="0" lang="en-US" sz="11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404640" y="108000"/>
            <a:ext cx="3657600" cy="23623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" descr=""/>
          <p:cNvPicPr/>
          <p:nvPr/>
        </p:nvPicPr>
        <p:blipFill>
          <a:blip r:embed="rId2"/>
          <a:stretch/>
        </p:blipFill>
        <p:spPr>
          <a:xfrm>
            <a:off x="4221000" y="108000"/>
            <a:ext cx="990720" cy="23623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4" descr=""/>
          <p:cNvPicPr/>
          <p:nvPr/>
        </p:nvPicPr>
        <p:blipFill>
          <a:blip r:embed="rId3"/>
          <a:stretch/>
        </p:blipFill>
        <p:spPr>
          <a:xfrm>
            <a:off x="404640" y="2627280"/>
            <a:ext cx="3657600" cy="23623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5" descr=""/>
          <p:cNvPicPr/>
          <p:nvPr/>
        </p:nvPicPr>
        <p:blipFill>
          <a:blip r:embed="rId4"/>
          <a:stretch/>
        </p:blipFill>
        <p:spPr>
          <a:xfrm>
            <a:off x="4221000" y="2627280"/>
            <a:ext cx="990720" cy="23623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6" descr=""/>
          <p:cNvPicPr/>
          <p:nvPr/>
        </p:nvPicPr>
        <p:blipFill>
          <a:blip r:embed="rId5"/>
          <a:stretch/>
        </p:blipFill>
        <p:spPr>
          <a:xfrm>
            <a:off x="404640" y="5305320"/>
            <a:ext cx="3657600" cy="23623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7" descr=""/>
          <p:cNvPicPr/>
          <p:nvPr/>
        </p:nvPicPr>
        <p:blipFill>
          <a:blip r:embed="rId6"/>
          <a:stretch/>
        </p:blipFill>
        <p:spPr>
          <a:xfrm>
            <a:off x="4221000" y="5305320"/>
            <a:ext cx="990720" cy="2362320"/>
          </a:xfrm>
          <a:prstGeom prst="rect">
            <a:avLst/>
          </a:prstGeom>
          <a:ln w="0">
            <a:noFill/>
          </a:ln>
        </p:spPr>
      </p:pic>
      <p:sp>
        <p:nvSpPr>
          <p:cNvPr id="48" name="Text Box 2"/>
          <p:cNvSpPr/>
          <p:nvPr/>
        </p:nvSpPr>
        <p:spPr>
          <a:xfrm>
            <a:off x="0" y="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0" y="255600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0" name="Text Box 12"/>
          <p:cNvSpPr/>
          <p:nvPr/>
        </p:nvSpPr>
        <p:spPr>
          <a:xfrm>
            <a:off x="31680" y="523404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C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1" name="Text Box 11"/>
          <p:cNvSpPr/>
          <p:nvPr/>
        </p:nvSpPr>
        <p:spPr>
          <a:xfrm>
            <a:off x="2421000" y="2843280"/>
            <a:ext cx="37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2" name="Line 26"/>
          <p:cNvSpPr/>
          <p:nvPr/>
        </p:nvSpPr>
        <p:spPr>
          <a:xfrm>
            <a:off x="2438280" y="302436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3" name="Text Box 11"/>
          <p:cNvSpPr/>
          <p:nvPr/>
        </p:nvSpPr>
        <p:spPr>
          <a:xfrm>
            <a:off x="4869000" y="3203640"/>
            <a:ext cx="37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4" name="Line 26"/>
          <p:cNvSpPr/>
          <p:nvPr/>
        </p:nvSpPr>
        <p:spPr>
          <a:xfrm>
            <a:off x="4919760" y="338472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9T09:26:31Z</dcterms:created>
  <dc:creator>USER</dc:creator>
  <dc:description/>
  <dc:language>en-US</dc:language>
  <cp:lastModifiedBy>Edward Visser</cp:lastModifiedBy>
  <dcterms:modified xsi:type="dcterms:W3CDTF">2016-02-11T12:45:54Z</dcterms:modified>
  <cp:revision>111</cp:revision>
  <dc:subject/>
  <dc:title>PowerPoint Presentation</dc:title>
</cp:coreProperties>
</file>